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43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b="1" dirty="0">
                <a:solidFill>
                  <a:schemeClr val="bg1"/>
                </a:solidFill>
              </a:rPr>
              <a:t>Impact of the 2022 Ambulatory Blood Pressure Monitoring Guidelines on blood pressure phenotypes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transplant patients</a:t>
            </a:r>
            <a:endParaRPr lang="en-GB" sz="12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14809"/>
            <a:ext cx="11838369" cy="5168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5000"/>
              </a:lnSpc>
            </a:pPr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evaluate the impact of the 2022 ABPM guidelines on diagnosing hypertension phenotypes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</a:t>
            </a:r>
          </a:p>
          <a:p>
            <a:pPr>
              <a:lnSpc>
                <a:spcPct val="75000"/>
              </a:lnSpc>
            </a:pPr>
            <a:r>
              <a:rPr lang="en-GB" dirty="0">
                <a:solidFill>
                  <a:schemeClr val="bg1"/>
                </a:solidFill>
              </a:rPr>
              <a:t>transplant recipients and their association with elevated arterial stiffness (AASI), compared to the 2014 guideline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235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alani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2022 ABPM guidelines identified a higher proportion of hypertension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transplant recipients and were more effective in detecting abnormalities associated with AASI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457664-2545-AF4F-5C31-480362DC4782}"/>
              </a:ext>
            </a:extLst>
          </p:cNvPr>
          <p:cNvSpPr txBox="1"/>
          <p:nvPr/>
        </p:nvSpPr>
        <p:spPr>
          <a:xfrm>
            <a:off x="6649375" y="1758951"/>
            <a:ext cx="1235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RESULT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7D97126-A5E6-6F3C-18F9-833F7C24F3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246" y="2400886"/>
            <a:ext cx="6256129" cy="20523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0D1AB3-17EE-25AB-5D1A-4CC728A27D4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052" t="2635" r="5613" b="41311"/>
          <a:stretch>
            <a:fillRect/>
          </a:stretch>
        </p:blipFill>
        <p:spPr>
          <a:xfrm>
            <a:off x="7679856" y="1821004"/>
            <a:ext cx="4338695" cy="225412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FA0AE9B-9DE8-9A45-FDAB-514486B7908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493" t="62013" r="8047" b="5301"/>
          <a:stretch>
            <a:fillRect/>
          </a:stretch>
        </p:blipFill>
        <p:spPr>
          <a:xfrm>
            <a:off x="7670897" y="4192882"/>
            <a:ext cx="4199030" cy="1314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4</TotalTime>
  <Words>9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61</cp:revision>
  <dcterms:created xsi:type="dcterms:W3CDTF">2019-06-13T12:30:18Z</dcterms:created>
  <dcterms:modified xsi:type="dcterms:W3CDTF">2026-02-24T09:22:00Z</dcterms:modified>
</cp:coreProperties>
</file>